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revisionInfo.xml" ContentType="application/vnd.ms-powerpoint.revisioninfo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65" r:id="rId2"/>
    <p:sldId id="264" r:id="rId3"/>
    <p:sldId id="263" r:id="rId4"/>
  </p:sldIdLst>
  <p:sldSz cx="6264275" cy="990600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197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5F3BA"/>
    <a:srgbClr val="008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889" autoAdjust="0"/>
    <p:restoredTop sz="88174" autoAdjust="0"/>
  </p:normalViewPr>
  <p:slideViewPr>
    <p:cSldViewPr snapToGrid="0">
      <p:cViewPr>
        <p:scale>
          <a:sx n="100" d="100"/>
          <a:sy n="100" d="100"/>
        </p:scale>
        <p:origin x="-1110" y="924"/>
      </p:cViewPr>
      <p:guideLst>
        <p:guide orient="horz" pos="3120"/>
        <p:guide pos="197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17" Type="http://schemas.microsoft.com/office/2015/10/relationships/revisionInfo" Target="revisionInfo.xml"/>
   <Relationship Id="rId2" Type="http://schemas.openxmlformats.org/officeDocument/2006/relationships/slide" Target="slides/slide1.xml"/>
   <Relationship Id="rId3" Type="http://schemas.openxmlformats.org/officeDocument/2006/relationships/slide" Target="slides/slide2.xml"/>
   <Relationship Id="rId4" Type="http://schemas.openxmlformats.org/officeDocument/2006/relationships/slide" Target="slides/slide3.xml"/>
   <Relationship Id="rId5" Type="http://schemas.openxmlformats.org/officeDocument/2006/relationships/notesMaster" Target="notesMasters/notesMaster1.xml"/>
   <Relationship Id="rId6" Type="http://schemas.openxmlformats.org/officeDocument/2006/relationships/presProps" Target="presProps.xml"/>
   <Relationship Id="rId7" Type="http://schemas.openxmlformats.org/officeDocument/2006/relationships/viewProps" Target="viewProps.xml"/>
   <Relationship Id="rId8" Type="http://schemas.openxmlformats.org/officeDocument/2006/relationships/theme" Target="theme/theme1.xml"/>
   <Relationship Id="rId9" Type="http://schemas.openxmlformats.org/officeDocument/2006/relationships/tableStyles" Target="tableStyles.xml"/>
</Relationships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6EC320-1346-498E-A4DB-2C6380AEF1D5}" type="datetimeFigureOut">
              <a:rPr lang="en-GB" smtClean="0"/>
              <a:t>24/07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9975" y="1241425"/>
            <a:ext cx="21177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3719B9-A0DF-4D77-85B4-AA1736239C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36401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 = '1.0' encoding = 'UTF-8' standalone = 'yes'?>
<Relationships xmlns="http://schemas.openxmlformats.org/package/2006/relationships">
   <Relationship Id="rId1" Type="http://schemas.openxmlformats.org/officeDocument/2006/relationships/notesMaster" Target="../notesMasters/notesMaster1.xml"/>
   <Relationship Id="rId2" Type="http://schemas.openxmlformats.org/officeDocument/2006/relationships/slide" Target="../slides/slide1.xml"/>
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/>
              <a:t>Scale 1um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1B13A68-0D65-49DA-B67D-590F6B986786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7572678"/>
      </p:ext>
    </p:extLst>
  </p:cSld>
  <p:clrMapOvr>
    <a:masterClrMapping/>
  </p:clrMapOvr>
</p:note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621191"/>
            <a:ext cx="5324634" cy="3448756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5202944"/>
            <a:ext cx="4698206" cy="2391656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C886-0E92-4CBB-B56C-9BD0EB9BBF21}" type="datetimeFigureOut">
              <a:rPr lang="en-GB" smtClean="0"/>
              <a:t>24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37B87-B065-4D82-86D5-71DA88E164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1149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C886-0E92-4CBB-B56C-9BD0EB9BBF21}" type="datetimeFigureOut">
              <a:rPr lang="en-GB" smtClean="0"/>
              <a:t>24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37B87-B065-4D82-86D5-71DA88E164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071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527403"/>
            <a:ext cx="1350734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527403"/>
            <a:ext cx="3973899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C886-0E92-4CBB-B56C-9BD0EB9BBF21}" type="datetimeFigureOut">
              <a:rPr lang="en-GB" smtClean="0"/>
              <a:t>24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37B87-B065-4D82-86D5-71DA88E164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79649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C886-0E92-4CBB-B56C-9BD0EB9BBF21}" type="datetimeFigureOut">
              <a:rPr lang="en-GB" smtClean="0"/>
              <a:t>24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37B87-B065-4D82-86D5-71DA88E164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20887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2469624"/>
            <a:ext cx="5402937" cy="4120620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6629226"/>
            <a:ext cx="5402937" cy="2166937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C886-0E92-4CBB-B56C-9BD0EB9BBF21}" type="datetimeFigureOut">
              <a:rPr lang="en-GB" smtClean="0"/>
              <a:t>24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37B87-B065-4D82-86D5-71DA88E164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46492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2637014"/>
            <a:ext cx="2662317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2637014"/>
            <a:ext cx="2662317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C886-0E92-4CBB-B56C-9BD0EB9BBF21}" type="datetimeFigureOut">
              <a:rPr lang="en-GB" smtClean="0"/>
              <a:t>24/07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37B87-B065-4D82-86D5-71DA88E164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5983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27405"/>
            <a:ext cx="5402937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2428347"/>
            <a:ext cx="2650082" cy="1190095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3618442"/>
            <a:ext cx="2650082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2428347"/>
            <a:ext cx="2663133" cy="1190095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3618442"/>
            <a:ext cx="266313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C886-0E92-4CBB-B56C-9BD0EB9BBF21}" type="datetimeFigureOut">
              <a:rPr lang="en-GB" smtClean="0"/>
              <a:t>24/07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37B87-B065-4D82-86D5-71DA88E164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74121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C886-0E92-4CBB-B56C-9BD0EB9BBF21}" type="datetimeFigureOut">
              <a:rPr lang="en-GB" smtClean="0"/>
              <a:t>24/07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37B87-B065-4D82-86D5-71DA88E164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066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C886-0E92-4CBB-B56C-9BD0EB9BBF21}" type="datetimeFigureOut">
              <a:rPr lang="en-GB" smtClean="0"/>
              <a:t>24/07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37B87-B065-4D82-86D5-71DA88E164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64792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660400"/>
            <a:ext cx="2020392" cy="2311400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1426283"/>
            <a:ext cx="3171289" cy="7039681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971800"/>
            <a:ext cx="2020392" cy="5505627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C886-0E92-4CBB-B56C-9BD0EB9BBF21}" type="datetimeFigureOut">
              <a:rPr lang="en-GB" smtClean="0"/>
              <a:t>24/07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37B87-B065-4D82-86D5-71DA88E164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9130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660400"/>
            <a:ext cx="2020392" cy="2311400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1426283"/>
            <a:ext cx="3171289" cy="7039681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971800"/>
            <a:ext cx="2020392" cy="5505627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C886-0E92-4CBB-B56C-9BD0EB9BBF21}" type="datetimeFigureOut">
              <a:rPr lang="en-GB" smtClean="0"/>
              <a:t>24/07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37B87-B065-4D82-86D5-71DA88E164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409195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527405"/>
            <a:ext cx="5402937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2637014"/>
            <a:ext cx="5402937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9181397"/>
            <a:ext cx="1409462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46C886-0E92-4CBB-B56C-9BD0EB9BBF21}" type="datetimeFigureOut">
              <a:rPr lang="en-GB" smtClean="0"/>
              <a:t>24/0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9181397"/>
            <a:ext cx="2114193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9181397"/>
            <a:ext cx="1409462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B37B87-B065-4D82-86D5-71DA88E164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525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26455" rtl="0" eaLnBrk="1" latinLnBrk="0" hangingPunct="1">
        <a:lnSpc>
          <a:spcPct val="90000"/>
        </a:lnSpc>
        <a:spcBef>
          <a:spcPct val="0"/>
        </a:spcBef>
        <a:buNone/>
        <a:defRPr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0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10" Type="http://schemas.openxmlformats.org/officeDocument/2006/relationships/image" Target="../media/image8.emf"/>
   <Relationship Id="rId2" Type="http://schemas.openxmlformats.org/officeDocument/2006/relationships/notesSlide" Target="../notesSlides/notesSlide1.xml"/>
   <Relationship Id="rId3" Type="http://schemas.openxmlformats.org/officeDocument/2006/relationships/image" Target="../media/image1.tiff"/>
   <Relationship Id="rId4" Type="http://schemas.openxmlformats.org/officeDocument/2006/relationships/image" Target="../media/image2.tiff"/>
   <Relationship Id="rId5" Type="http://schemas.openxmlformats.org/officeDocument/2006/relationships/image" Target="../media/image3.tiff"/>
   <Relationship Id="rId6" Type="http://schemas.openxmlformats.org/officeDocument/2006/relationships/image" Target="../media/image4.tiff"/>
   <Relationship Id="rId7" Type="http://schemas.openxmlformats.org/officeDocument/2006/relationships/image" Target="../media/image5.tiff"/>
   <Relationship Id="rId8" Type="http://schemas.openxmlformats.org/officeDocument/2006/relationships/image" Target="../media/image6.tiff"/>
   <Relationship Id="rId9" Type="http://schemas.openxmlformats.org/officeDocument/2006/relationships/image" Target="../media/image7.emf"/>
</Relationships>
</file>

<file path=ppt/slides/_rels/slide2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9.png"/>
</Relationships>
</file>

<file path=ppt/slides/_rels/slide3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10.pn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2" descr="W:\Gribble\Larry\Insl5 Paper 1\Imaris Surfaces - Supplementary\Example Imaris Images\Cropped_1_2018-05-14T10-45-16.039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818" r="9600"/>
          <a:stretch/>
        </p:blipFill>
        <p:spPr bwMode="auto">
          <a:xfrm>
            <a:off x="281135" y="3095782"/>
            <a:ext cx="2612331" cy="16479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3" descr="W:\Gribble\Larry\Insl5 Paper 1\Imaris Surfaces - Supplementary\Example Imaris Images\Cropped_1_2018-05-14T10-46-04.043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818" r="9600"/>
          <a:stretch/>
        </p:blipFill>
        <p:spPr bwMode="auto">
          <a:xfrm>
            <a:off x="281135" y="1289059"/>
            <a:ext cx="2612331" cy="16479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3" descr="W:\Gribble\Larry\Insl5 Paper 1\Imaris Surfaces - Supplementary\Example Imaris Images\Cropped_1_2018-05-14T10-46-19.917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260" r="9600"/>
          <a:stretch/>
        </p:blipFill>
        <p:spPr bwMode="auto">
          <a:xfrm>
            <a:off x="2991122" y="3095782"/>
            <a:ext cx="2612331" cy="16598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1158918" y="2727001"/>
            <a:ext cx="1775897" cy="2188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22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P-1</a:t>
            </a:r>
            <a:r>
              <a:rPr lang="en-GB" sz="822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822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YY</a:t>
            </a:r>
            <a:r>
              <a:rPr lang="en-GB" sz="822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822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SL5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22315" y="3059812"/>
            <a:ext cx="2195554" cy="2188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22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pped surfaces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322102" y="5263116"/>
            <a:ext cx="1285639" cy="2399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59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0" name="Rectangle 19"/>
          <p:cNvSpPr/>
          <p:nvPr/>
        </p:nvSpPr>
        <p:spPr>
          <a:xfrm>
            <a:off x="2974100" y="3059812"/>
            <a:ext cx="1539291" cy="21884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GB" sz="822" dirty="0">
                <a:solidFill>
                  <a:srgbClr val="9148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iple positive surfaces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139748" y="4518862"/>
            <a:ext cx="1775897" cy="2188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22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P-1</a:t>
            </a:r>
            <a:r>
              <a:rPr lang="en-GB" sz="822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822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YY</a:t>
            </a:r>
            <a:r>
              <a:rPr lang="en-GB" sz="822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822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SL5</a:t>
            </a:r>
          </a:p>
        </p:txBody>
      </p:sp>
      <p:grpSp>
        <p:nvGrpSpPr>
          <p:cNvPr id="39" name="Group 38"/>
          <p:cNvGrpSpPr/>
          <p:nvPr/>
        </p:nvGrpSpPr>
        <p:grpSpPr>
          <a:xfrm>
            <a:off x="289835" y="4549657"/>
            <a:ext cx="351590" cy="185411"/>
            <a:chOff x="389314" y="4130428"/>
            <a:chExt cx="384914" cy="202984"/>
          </a:xfrm>
        </p:grpSpPr>
        <p:sp>
          <p:nvSpPr>
            <p:cNvPr id="37" name="Rectangle 36"/>
            <p:cNvSpPr/>
            <p:nvPr/>
          </p:nvSpPr>
          <p:spPr>
            <a:xfrm>
              <a:off x="389314" y="4130428"/>
              <a:ext cx="384914" cy="202984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4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Straight Connector 35"/>
            <p:cNvCxnSpPr/>
            <p:nvPr/>
          </p:nvCxnSpPr>
          <p:spPr>
            <a:xfrm>
              <a:off x="427270" y="4283968"/>
              <a:ext cx="291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8" name="Group 47"/>
          <p:cNvGrpSpPr/>
          <p:nvPr/>
        </p:nvGrpSpPr>
        <p:grpSpPr>
          <a:xfrm>
            <a:off x="3009289" y="4549657"/>
            <a:ext cx="351590" cy="185411"/>
            <a:chOff x="389314" y="4130428"/>
            <a:chExt cx="384914" cy="202984"/>
          </a:xfrm>
        </p:grpSpPr>
        <p:sp>
          <p:nvSpPr>
            <p:cNvPr id="49" name="Rectangle 48"/>
            <p:cNvSpPr/>
            <p:nvPr/>
          </p:nvSpPr>
          <p:spPr>
            <a:xfrm>
              <a:off x="389314" y="4130428"/>
              <a:ext cx="384914" cy="202984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4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" name="Straight Connector 49"/>
            <p:cNvCxnSpPr/>
            <p:nvPr/>
          </p:nvCxnSpPr>
          <p:spPr>
            <a:xfrm>
              <a:off x="427270" y="4283968"/>
              <a:ext cx="291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" name="Rectangle 52"/>
          <p:cNvSpPr/>
          <p:nvPr/>
        </p:nvSpPr>
        <p:spPr>
          <a:xfrm>
            <a:off x="289835" y="2728596"/>
            <a:ext cx="351590" cy="185411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44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Straight Connector 53"/>
          <p:cNvCxnSpPr/>
          <p:nvPr/>
        </p:nvCxnSpPr>
        <p:spPr>
          <a:xfrm>
            <a:off x="324505" y="2868843"/>
            <a:ext cx="266355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 1"/>
          <p:cNvGrpSpPr/>
          <p:nvPr/>
        </p:nvGrpSpPr>
        <p:grpSpPr>
          <a:xfrm>
            <a:off x="281135" y="5281869"/>
            <a:ext cx="3966724" cy="1785921"/>
            <a:chOff x="360643" y="6876256"/>
            <a:chExt cx="4342688" cy="1955190"/>
          </a:xfrm>
        </p:grpSpPr>
        <p:pic>
          <p:nvPicPr>
            <p:cNvPr id="1026" name="Picture 2" descr="W:\Gribble\Larry\Insl5 Paper 1\Imaris Surfaces - Supplementary\Example Imaris Images\New\Triple labelled slide 1c cropped_2018-05-14T16-27-41.184.tif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67" r="29545"/>
            <a:stretch/>
          </p:blipFill>
          <p:spPr bwMode="auto">
            <a:xfrm>
              <a:off x="3284984" y="6885679"/>
              <a:ext cx="1361738" cy="1929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7" name="Picture 3" descr="W:\Gribble\Larry\Insl5 Paper 1\Imaris Surfaces - Supplementary\Example Imaris Images\New\Triple labelled slide 1c cropped_2018-05-14T16-27-22.372.tif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67" r="29545"/>
            <a:stretch/>
          </p:blipFill>
          <p:spPr bwMode="auto">
            <a:xfrm>
              <a:off x="1844824" y="6880031"/>
              <a:ext cx="1361738" cy="1929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8" name="Picture 4" descr="W:\Gribble\Larry\Insl5 Paper 1\Imaris Surfaces - Supplementary\Example Imaris Images\New\Triple labelled slide 1c cropped_2018-05-14T16-27-35.253.tif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67" r="29545"/>
            <a:stretch/>
          </p:blipFill>
          <p:spPr bwMode="auto">
            <a:xfrm>
              <a:off x="399538" y="6880031"/>
              <a:ext cx="1361738" cy="1929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TextBox 14"/>
            <p:cNvSpPr txBox="1"/>
            <p:nvPr/>
          </p:nvSpPr>
          <p:spPr>
            <a:xfrm>
              <a:off x="1364644" y="8314863"/>
              <a:ext cx="446959" cy="5165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22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8  </a:t>
              </a:r>
              <a:br>
                <a:rPr lang="en-GB" sz="822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GB" sz="822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55</a:t>
              </a:r>
              <a:r>
                <a:rPr lang="en-GB" sz="822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br>
                <a:rPr lang="en-GB" sz="822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GB" sz="822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3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844823" y="6876256"/>
              <a:ext cx="1356559" cy="2395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22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pped surfaces</a:t>
              </a:r>
              <a:endParaRPr lang="en-GB" sz="822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2" name="Straight Connector 61"/>
            <p:cNvCxnSpPr/>
            <p:nvPr/>
          </p:nvCxnSpPr>
          <p:spPr>
            <a:xfrm>
              <a:off x="439982" y="8735401"/>
              <a:ext cx="2052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/>
            <p:cNvSpPr txBox="1"/>
            <p:nvPr/>
          </p:nvSpPr>
          <p:spPr>
            <a:xfrm>
              <a:off x="360643" y="6876256"/>
              <a:ext cx="1440107" cy="2395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22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P-1 (triple labelled)</a:t>
              </a:r>
              <a:endParaRPr lang="en-GB" sz="822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262566" y="6876256"/>
              <a:ext cx="1383063" cy="2395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22" dirty="0">
                  <a:solidFill>
                    <a:srgbClr val="9148C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iple positive surfaces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256372" y="8312641"/>
              <a:ext cx="446959" cy="5165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22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8  </a:t>
              </a:r>
              <a:br>
                <a:rPr lang="en-GB" sz="822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GB" sz="822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55</a:t>
              </a:r>
              <a:r>
                <a:rPr lang="en-GB" sz="822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br>
                <a:rPr lang="en-GB" sz="822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GB" sz="822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3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2780928" y="8312641"/>
              <a:ext cx="446959" cy="5165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22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8  </a:t>
              </a:r>
              <a:br>
                <a:rPr lang="en-GB" sz="822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GB" sz="822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55</a:t>
              </a:r>
              <a:r>
                <a:rPr lang="en-GB" sz="822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br>
                <a:rPr lang="en-GB" sz="822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GB" sz="822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3</a:t>
              </a:r>
            </a:p>
          </p:txBody>
        </p:sp>
        <p:cxnSp>
          <p:nvCxnSpPr>
            <p:cNvPr id="44" name="Straight Connector 43"/>
            <p:cNvCxnSpPr/>
            <p:nvPr/>
          </p:nvCxnSpPr>
          <p:spPr>
            <a:xfrm>
              <a:off x="1914593" y="8735401"/>
              <a:ext cx="2052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3343929" y="8735401"/>
              <a:ext cx="2052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8" name="Picture 2" descr="W:\Gribble\Larry\Insl5 Paper 1\Imaris Surfaces - Supplementary\Primary Cultures sized1.emf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87347" y="987124"/>
            <a:ext cx="2496313" cy="21418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3" descr="W:\Gribble\Larry\Insl5 Paper 1\Imaris Surfaces - Supplementary\GLP-1 triplesized.emf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53329" y="5387294"/>
            <a:ext cx="2135959" cy="16336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5" name="TextBox 34"/>
          <p:cNvSpPr txBox="1"/>
          <p:nvPr/>
        </p:nvSpPr>
        <p:spPr>
          <a:xfrm>
            <a:off x="88646" y="1034040"/>
            <a:ext cx="5697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2814985" y="1044806"/>
            <a:ext cx="5697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87254" y="2889320"/>
            <a:ext cx="5697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2814985" y="2892937"/>
            <a:ext cx="5697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87254" y="5094150"/>
            <a:ext cx="5697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1464710" y="5090956"/>
            <a:ext cx="5697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2804878" y="5087939"/>
            <a:ext cx="5697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4166672" y="5334160"/>
            <a:ext cx="5697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29965349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763" y="1463033"/>
            <a:ext cx="5888748" cy="69799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41304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213" y="1552113"/>
            <a:ext cx="5403850" cy="5561035"/>
          </a:xfrm>
        </p:spPr>
      </p:pic>
    </p:spTree>
    <p:extLst>
      <p:ext uri="{BB962C8B-B14F-4D97-AF65-F5344CB8AC3E}">
        <p14:creationId xmlns:p14="http://schemas.microsoft.com/office/powerpoint/2010/main" val="19108301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45</TotalTime>
  <Words>36</Words>
  <Application>Microsoft Office PowerPoint</Application>
  <PresentationFormat>Custom</PresentationFormat>
  <Paragraphs>21</Paragraphs>
  <Slides>3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  <Company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>
  <cp:lastPrinted>2018-05-24T11:09:37Z</cp:lastPrinted>
</cp:coreProperties>
</file>